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13"/>
  </p:notesMasterIdLst>
  <p:sldIdLst>
    <p:sldId id="275" r:id="rId5"/>
    <p:sldId id="268" r:id="rId6"/>
    <p:sldId id="269" r:id="rId7"/>
    <p:sldId id="274" r:id="rId8"/>
    <p:sldId id="270" r:id="rId9"/>
    <p:sldId id="276" r:id="rId10"/>
    <p:sldId id="272" r:id="rId11"/>
    <p:sldId id="266" r:id="rId12"/>
  </p:sldIdLst>
  <p:sldSz cx="9144000" cy="12801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FC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177" autoAdjust="0"/>
    <p:restoredTop sz="94811"/>
  </p:normalViewPr>
  <p:slideViewPr>
    <p:cSldViewPr snapToGrid="0">
      <p:cViewPr>
        <p:scale>
          <a:sx n="70" d="100"/>
          <a:sy n="70" d="100"/>
        </p:scale>
        <p:origin x="216" y="-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EF2A72-6A79-B348-99F6-22730BA79AB4}" type="datetimeFigureOut">
              <a:rPr lang="en-TH" smtClean="0"/>
              <a:t>05/21/2026</a:t>
            </a:fld>
            <a:endParaRPr lang="en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26FC63-D052-0944-AF01-6D26FE078F5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117605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T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26FC63-D052-0944-AF01-6D26FE078F54}" type="slidenum">
              <a:rPr lang="en-TH" smtClean="0"/>
              <a:t>4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1361855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7275" y="1143000"/>
            <a:ext cx="2203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T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26FC63-D052-0944-AF01-6D26FE078F54}" type="slidenum">
              <a:rPr lang="en-TH" smtClean="0"/>
              <a:t>7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9283026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7275" y="1143000"/>
            <a:ext cx="22034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T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26FC63-D052-0944-AF01-6D26FE078F54}" type="slidenum">
              <a:rPr lang="en-TH" smtClean="0"/>
              <a:t>8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5755843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095078"/>
            <a:ext cx="7772400" cy="445685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723804"/>
            <a:ext cx="6858000" cy="309075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226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19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81567"/>
            <a:ext cx="1971675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81567"/>
            <a:ext cx="5800725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24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670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191514"/>
            <a:ext cx="7886700" cy="532510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567000"/>
            <a:ext cx="7886700" cy="28003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460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407833"/>
            <a:ext cx="388620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407833"/>
            <a:ext cx="388620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456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81570"/>
            <a:ext cx="7886700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138171"/>
            <a:ext cx="3868340" cy="1537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676140"/>
            <a:ext cx="3868340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138171"/>
            <a:ext cx="3887391" cy="1537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676140"/>
            <a:ext cx="388739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12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760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77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53440"/>
            <a:ext cx="2949178" cy="29870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843196"/>
            <a:ext cx="4629150" cy="90974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40480"/>
            <a:ext cx="2949178" cy="711496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232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53440"/>
            <a:ext cx="2949178" cy="29870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843196"/>
            <a:ext cx="4629150" cy="909743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40480"/>
            <a:ext cx="2949178" cy="711496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841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81570"/>
            <a:ext cx="788670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407833"/>
            <a:ext cx="788670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865189"/>
            <a:ext cx="20574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9C3DA8-EF37-4F22-AF4E-92A26222A275}" type="datetimeFigureOut">
              <a:rPr lang="en-US" smtClean="0"/>
              <a:t>5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865189"/>
            <a:ext cx="30861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865189"/>
            <a:ext cx="20574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065405-5ED3-4C26-91F6-D33B1A2DB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784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gi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gif"/><Relationship Id="rId9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emf"/><Relationship Id="rId4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15ED21B-D120-4F59-4ABB-ECBE4B6C3EDE}"/>
              </a:ext>
            </a:extLst>
          </p:cNvPr>
          <p:cNvSpPr txBox="1"/>
          <p:nvPr/>
        </p:nvSpPr>
        <p:spPr>
          <a:xfrm>
            <a:off x="994228" y="10196660"/>
            <a:ext cx="7300685" cy="3258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Figure S1.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hemical structure of natural products derived phenanthrene</a:t>
            </a:r>
            <a:r>
              <a:rPr lang="en-US" sz="1400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‐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type compounds. </a:t>
            </a:r>
            <a:endParaRPr lang="en-TH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Cordia New" panose="020B0304020202020204" pitchFamily="34" charset="-34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6295F14-7D47-5F7C-3C86-ED5DA08E5CFB}"/>
              </a:ext>
            </a:extLst>
          </p:cNvPr>
          <p:cNvSpPr txBox="1"/>
          <p:nvPr/>
        </p:nvSpPr>
        <p:spPr>
          <a:xfrm>
            <a:off x="921657" y="392259"/>
            <a:ext cx="7300685" cy="3926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Supplementary Figures </a:t>
            </a:r>
            <a:endParaRPr lang="en-TH" b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Cordia New" panose="020B0304020202020204" pitchFamily="34" charset="-34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E070F4E-B60A-AB49-6FAF-87F7B7AF8F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" r="14286" b="20981"/>
          <a:stretch>
            <a:fillRect/>
          </a:stretch>
        </p:blipFill>
        <p:spPr>
          <a:xfrm>
            <a:off x="1030513" y="784931"/>
            <a:ext cx="7300685" cy="82429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5471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436CE47-CF58-0D14-D225-80E20CB2AD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21" y="2400846"/>
            <a:ext cx="5462489" cy="2798307"/>
          </a:xfrm>
          <a:prstGeom prst="rect">
            <a:avLst/>
          </a:prstGeom>
        </p:spPr>
      </p:pic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540C49D-C1F3-0CA8-C5EC-5C6AFA8190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4095358"/>
              </p:ext>
            </p:extLst>
          </p:nvPr>
        </p:nvGraphicFramePr>
        <p:xfrm>
          <a:off x="5571331" y="2722625"/>
          <a:ext cx="3311787" cy="1788160"/>
        </p:xfrm>
        <a:graphic>
          <a:graphicData uri="http://schemas.openxmlformats.org/drawingml/2006/table">
            <a:tbl>
              <a:tblPr firstRow="1" bandRow="1">
                <a:tableStyleId>{7DF18680-E054-41AD-8BC1-D1AEF772440D}</a:tableStyleId>
              </a:tblPr>
              <a:tblGrid>
                <a:gridCol w="1914584">
                  <a:extLst>
                    <a:ext uri="{9D8B030D-6E8A-4147-A177-3AD203B41FA5}">
                      <a16:colId xmlns:a16="http://schemas.microsoft.com/office/drawing/2014/main" val="3884822731"/>
                    </a:ext>
                  </a:extLst>
                </a:gridCol>
                <a:gridCol w="1397203">
                  <a:extLst>
                    <a:ext uri="{9D8B030D-6E8A-4147-A177-3AD203B41FA5}">
                      <a16:colId xmlns:a16="http://schemas.microsoft.com/office/drawing/2014/main" val="2768641477"/>
                    </a:ext>
                  </a:extLst>
                </a:gridCol>
              </a:tblGrid>
              <a:tr h="141143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T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  <a:r>
                        <a:rPr lang="en-US" sz="14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SD (</a:t>
                      </a:r>
                      <a:r>
                        <a:rPr lang="el-GR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94944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drocrumenol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2 ± 0.2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8629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drocrumenol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.9 ±  0.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79195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ripedin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6 ± 0.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2878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yunnanin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07 ± 0.2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7613987"/>
                  </a:ext>
                </a:extLst>
              </a:tr>
            </a:tbl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id="{D348BC6D-3C0E-0133-B475-96E24FC98D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073" y="5127162"/>
            <a:ext cx="3930650" cy="284480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A76DAB9-A2F5-3ED7-D979-186AF5DEE7B9}"/>
              </a:ext>
            </a:extLst>
          </p:cNvPr>
          <p:cNvSpPr/>
          <p:nvPr/>
        </p:nvSpPr>
        <p:spPr>
          <a:xfrm>
            <a:off x="0" y="2122784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B3A13ECD-5030-2CE1-2A34-D343616F68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4118573"/>
              </p:ext>
            </p:extLst>
          </p:nvPr>
        </p:nvGraphicFramePr>
        <p:xfrm>
          <a:off x="5571331" y="6400800"/>
          <a:ext cx="3388596" cy="675640"/>
        </p:xfrm>
        <a:graphic>
          <a:graphicData uri="http://schemas.openxmlformats.org/drawingml/2006/table">
            <a:tbl>
              <a:tblPr firstRow="1" bandRow="1">
                <a:tableStyleId>{7DF18680-E054-41AD-8BC1-D1AEF772440D}</a:tableStyleId>
              </a:tblPr>
              <a:tblGrid>
                <a:gridCol w="1604402">
                  <a:extLst>
                    <a:ext uri="{9D8B030D-6E8A-4147-A177-3AD203B41FA5}">
                      <a16:colId xmlns:a16="http://schemas.microsoft.com/office/drawing/2014/main" val="3884822731"/>
                    </a:ext>
                  </a:extLst>
                </a:gridCol>
                <a:gridCol w="1784194">
                  <a:extLst>
                    <a:ext uri="{9D8B030D-6E8A-4147-A177-3AD203B41FA5}">
                      <a16:colId xmlns:a16="http://schemas.microsoft.com/office/drawing/2014/main" val="2768641477"/>
                    </a:ext>
                  </a:extLst>
                </a:gridCol>
              </a:tblGrid>
              <a:tr h="141143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T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</a:t>
                      </a:r>
                      <a:r>
                        <a:rPr lang="en-US" sz="14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SD (</a:t>
                      </a:r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94944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xorubic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9 ± 0.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862984"/>
                  </a:ext>
                </a:extLst>
              </a:tr>
            </a:tbl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471F6ECC-6B8F-BB9C-C13F-4E8C2306E8AC}"/>
              </a:ext>
            </a:extLst>
          </p:cNvPr>
          <p:cNvSpPr/>
          <p:nvPr/>
        </p:nvSpPr>
        <p:spPr>
          <a:xfrm>
            <a:off x="5443604" y="2122784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4B43A4B-0CAE-9F91-5705-F59E3DAF0938}"/>
              </a:ext>
            </a:extLst>
          </p:cNvPr>
          <p:cNvSpPr/>
          <p:nvPr/>
        </p:nvSpPr>
        <p:spPr>
          <a:xfrm>
            <a:off x="70208" y="4936180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A244598-1AD4-9D69-7C27-EB99F8CAA272}"/>
              </a:ext>
            </a:extLst>
          </p:cNvPr>
          <p:cNvSpPr/>
          <p:nvPr/>
        </p:nvSpPr>
        <p:spPr>
          <a:xfrm>
            <a:off x="5443604" y="5669218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CD169F7-183E-4E52-FFC1-649CD2652343}"/>
              </a:ext>
            </a:extLst>
          </p:cNvPr>
          <p:cNvSpPr txBox="1"/>
          <p:nvPr/>
        </p:nvSpPr>
        <p:spPr>
          <a:xfrm>
            <a:off x="556344" y="8079473"/>
            <a:ext cx="8207829" cy="18124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Figure S2. Natural products derived phenanthrene</a:t>
            </a:r>
            <a:r>
              <a:rPr lang="en-US" sz="1400" b="1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‐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type compounds for cytotoxicity in MOLT4 cells and IC</a:t>
            </a:r>
            <a:r>
              <a:rPr lang="en-US" sz="1400" b="1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₅₀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determination.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(A) Dose-response curves for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Dendrocrumenols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B and D,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, Phoyunnanin E (0.01-20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). Data are mean ± SD (n = 3) and were fit by nonlinear regression to calculate IC</a:t>
            </a:r>
            <a:r>
              <a:rPr lang="en-US" sz="1400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₅₀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values. (B) Table of IC</a:t>
            </a:r>
            <a:r>
              <a:rPr lang="en-US" sz="1400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₅₀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values derived from the curves in (A).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showed the lowest IC</a:t>
            </a:r>
            <a:r>
              <a:rPr lang="en-US" sz="1400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₅₀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among natural compounds, identifying it as the lead for further mechanistic studies. (C) Dose-response curves for positive control (0.01-20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n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). Data are mean ± SD (n = 3) and were fit by nonlinear regression to calculate IC</a:t>
            </a:r>
            <a:r>
              <a:rPr lang="en-US" sz="1400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₅₀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values. (D) Table of IC</a:t>
            </a:r>
            <a:r>
              <a:rPr lang="en-US" sz="1400" kern="100" dirty="0">
                <a:effectLst/>
                <a:latin typeface="Cambria Math" panose="02040503050406030204" pitchFamily="18" charset="0"/>
                <a:ea typeface="Aptos" panose="020B0004020202020204" pitchFamily="34" charset="0"/>
                <a:cs typeface="Cambria Math" panose="02040503050406030204" pitchFamily="18" charset="0"/>
              </a:rPr>
              <a:t>₅₀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values derived from the curves in (C). </a:t>
            </a:r>
            <a:endParaRPr lang="en-TH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4743195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09F013-8501-62DE-DF32-3A5A30ACFA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>
            <a:extLst>
              <a:ext uri="{FF2B5EF4-FFF2-40B4-BE49-F238E27FC236}">
                <a16:creationId xmlns:a16="http://schemas.microsoft.com/office/drawing/2014/main" id="{488B227D-350A-7D3A-EF76-776DB34BD9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1532"/>
            <a:ext cx="9144000" cy="4334736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ADAB5E5-F9C5-5935-1A13-446FC896AE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504" y="4716701"/>
            <a:ext cx="2889754" cy="2091109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B018422F-648F-C6A3-AFE9-D247373A3DF3}"/>
              </a:ext>
            </a:extLst>
          </p:cNvPr>
          <p:cNvSpPr/>
          <p:nvPr/>
        </p:nvSpPr>
        <p:spPr>
          <a:xfrm>
            <a:off x="0" y="0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5F297E0-EDAF-10EB-C13F-EF2C8A6D3104}"/>
              </a:ext>
            </a:extLst>
          </p:cNvPr>
          <p:cNvSpPr/>
          <p:nvPr/>
        </p:nvSpPr>
        <p:spPr>
          <a:xfrm>
            <a:off x="16436" y="4496268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3495332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4FA490D-4F68-2FF3-A127-578375CA5BB0}"/>
              </a:ext>
            </a:extLst>
          </p:cNvPr>
          <p:cNvSpPr txBox="1"/>
          <p:nvPr/>
        </p:nvSpPr>
        <p:spPr>
          <a:xfrm>
            <a:off x="400315" y="8324952"/>
            <a:ext cx="8207829" cy="46423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>
              <a:lnSpc>
                <a:spcPct val="115000"/>
              </a:lnSpc>
              <a:spcAft>
                <a:spcPts val="800"/>
              </a:spcAft>
            </a:pPr>
            <a:r>
              <a:rPr lang="en-US" sz="1400" b="1" dirty="0"/>
              <a:t>Figure S3.</a:t>
            </a:r>
            <a:r>
              <a:rPr lang="en-US" sz="1400" dirty="0"/>
              <a:t> </a:t>
            </a:r>
            <a:r>
              <a:rPr lang="en-US" sz="1400" b="1" dirty="0" err="1"/>
              <a:t>Cypripedin</a:t>
            </a:r>
            <a:r>
              <a:rPr lang="en-US" sz="1400" b="1" dirty="0"/>
              <a:t> induces dose-dependent apoptosis in MOLT4 cells.</a:t>
            </a:r>
            <a:r>
              <a:rPr lang="en-US" sz="1400" dirty="0"/>
              <a:t> (A) MOLT4 cells were treated for 24 h with 0, 1, 2, 4, or 8 </a:t>
            </a:r>
            <a:r>
              <a:rPr lang="en-US" sz="1400" dirty="0" err="1"/>
              <a:t>μM</a:t>
            </a:r>
            <a:r>
              <a:rPr lang="en-US" sz="1400" dirty="0"/>
              <a:t> </a:t>
            </a:r>
            <a:r>
              <a:rPr lang="en-US" sz="1400" dirty="0" err="1"/>
              <a:t>Cypripedin</a:t>
            </a:r>
            <a:r>
              <a:rPr lang="en-US" sz="1400" dirty="0"/>
              <a:t> and then stained with Hoechst 33342 (blue) and propidium iodide (PI; red) to distinguish apoptotic versus necrotic cells. Representative phase-contrast images show cell shrinkage and membrane blebbing at increasing </a:t>
            </a:r>
            <a:r>
              <a:rPr lang="en-US" sz="1400" dirty="0" err="1"/>
              <a:t>Cypripedin</a:t>
            </a:r>
            <a:r>
              <a:rPr lang="en-US" sz="1400" dirty="0"/>
              <a:t> concentrations. Corresponding fluorescence micrographs of Hoechst 33342–stained nuclei reveal chromatin condensation and fragmentation; PI staining indicates minimal necrosis. (B) Quantification of apoptotic cells based on nuclear morphology (condensation/fragmentation) and PI exclusion. Bars represent mean ± SD (n = 3); (***p &lt; 0.001 vs. control; one-way ANOVA with Tukey’s post hoc test). Scale bar = 100 </a:t>
            </a:r>
            <a:r>
              <a:rPr lang="en-US" sz="1400" dirty="0" err="1"/>
              <a:t>μm</a:t>
            </a:r>
            <a:r>
              <a:rPr lang="en-US" sz="1400" dirty="0"/>
              <a:t> (magnification: 20x). (C) MOLT4 cells were treated for 24 h with 0, 1, 2, 4, or 8 </a:t>
            </a:r>
            <a:r>
              <a:rPr lang="en-US" sz="1400" dirty="0" err="1"/>
              <a:t>μM</a:t>
            </a:r>
            <a:r>
              <a:rPr lang="en-US" sz="1400" dirty="0"/>
              <a:t> </a:t>
            </a:r>
            <a:r>
              <a:rPr lang="en-US" sz="1400" dirty="0" err="1"/>
              <a:t>Cypripedin</a:t>
            </a:r>
            <a:r>
              <a:rPr lang="en-US" sz="1400" dirty="0"/>
              <a:t> and stained with Annexin V–FITC and propidium iodide (PI). Top panels: Representative density plots showing total cell populations gated to exclude debris. Bottom panels: Corresponding Annexin V/PI dot plots. Quadrants denote viable (Annexin V–/PI–, lower left), early apoptotic (Annexin V+/PI–, lower right), late apoptotic or secondary necrotic (Annexin V+/PI+, upper right), and necrotic (Annexin V–/PI+, upper left) cells. (D) Percentages of each population are indicated within the quadrants. With increasing </a:t>
            </a:r>
            <a:r>
              <a:rPr lang="en-US" sz="1400" dirty="0" err="1"/>
              <a:t>Cypripedin</a:t>
            </a:r>
            <a:r>
              <a:rPr lang="en-US" sz="1400" dirty="0"/>
              <a:t> concentration, the proportions of early and late apoptotic cells rise markedly, while necrosis remains minimal. Cells (n = 3) were analyzed using </a:t>
            </a:r>
            <a:r>
              <a:rPr lang="en-US" sz="1400" dirty="0" err="1"/>
              <a:t>Flowjo</a:t>
            </a:r>
            <a:r>
              <a:rPr lang="en-US" sz="1400" dirty="0"/>
              <a:t>; plots are representative of three independent experiments. </a:t>
            </a:r>
            <a:endParaRPr lang="en-TH" sz="1400" dirty="0"/>
          </a:p>
          <a:p>
            <a:pPr algn="thaiDist">
              <a:lnSpc>
                <a:spcPct val="115000"/>
              </a:lnSpc>
              <a:spcAft>
                <a:spcPts val="800"/>
              </a:spcAft>
              <a:buNone/>
            </a:pPr>
            <a:endParaRPr lang="en-TH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Cordia New" panose="020B0304020202020204" pitchFamily="34" charset="-34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6A6D3D6-772F-7BB4-40DA-CF59E2C32E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7770" y="310047"/>
            <a:ext cx="9144000" cy="50114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6D830F5-39A5-EC74-52D7-58243C0C60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076" y="5321471"/>
            <a:ext cx="4914900" cy="314960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E0E97002-00FC-ABC4-9A7E-614D4C7B78C8}"/>
              </a:ext>
            </a:extLst>
          </p:cNvPr>
          <p:cNvSpPr/>
          <p:nvPr/>
        </p:nvSpPr>
        <p:spPr>
          <a:xfrm>
            <a:off x="52076" y="0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46892A7-287A-F1EC-6FFB-EF72367844AE}"/>
              </a:ext>
            </a:extLst>
          </p:cNvPr>
          <p:cNvSpPr/>
          <p:nvPr/>
        </p:nvSpPr>
        <p:spPr>
          <a:xfrm>
            <a:off x="29818" y="5022362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7414846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196181-0B18-6644-3FB8-E0602274DD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B41EA19-DC33-306F-6A9C-41DCD55F78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316" y="-66812"/>
            <a:ext cx="5003800" cy="29083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394F5455-651C-92D1-D8C8-BB52DA9E8182}"/>
              </a:ext>
            </a:extLst>
          </p:cNvPr>
          <p:cNvSpPr/>
          <p:nvPr/>
        </p:nvSpPr>
        <p:spPr>
          <a:xfrm>
            <a:off x="3035" y="0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BC2EC9B-D175-A5C9-DDC8-4C489134C79D}"/>
              </a:ext>
            </a:extLst>
          </p:cNvPr>
          <p:cNvSpPr/>
          <p:nvPr/>
        </p:nvSpPr>
        <p:spPr>
          <a:xfrm>
            <a:off x="3974231" y="2524222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3DF1990-5CF4-67C5-F794-691328CB5111}"/>
              </a:ext>
            </a:extLst>
          </p:cNvPr>
          <p:cNvSpPr/>
          <p:nvPr/>
        </p:nvSpPr>
        <p:spPr>
          <a:xfrm>
            <a:off x="105334" y="7518996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9D63A72-F73E-B90C-C415-C2D3480C3D4D}"/>
              </a:ext>
            </a:extLst>
          </p:cNvPr>
          <p:cNvSpPr/>
          <p:nvPr/>
        </p:nvSpPr>
        <p:spPr>
          <a:xfrm>
            <a:off x="3309921" y="7438307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814D333-9A17-D5DB-F65E-AD3FAF1153C4}"/>
              </a:ext>
            </a:extLst>
          </p:cNvPr>
          <p:cNvSpPr/>
          <p:nvPr/>
        </p:nvSpPr>
        <p:spPr>
          <a:xfrm>
            <a:off x="23142" y="9836317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83A0601-0343-4BD4-5E3E-3F72E7CF74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637" y="2791756"/>
            <a:ext cx="3359951" cy="228593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FC535B2-5BF0-5BE5-D2C7-4577443FDA8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290" y="2741664"/>
            <a:ext cx="3657935" cy="248597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5671556-776B-E6DE-59A9-A693C69562F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8366" y="5160561"/>
            <a:ext cx="3245248" cy="220515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D8323B2-FA4F-D123-47EC-DC745843B73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01789" y="5338622"/>
            <a:ext cx="4676037" cy="228619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D2B7B6A-5C9A-3BD9-0064-794A70AE0BA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03" y="7821412"/>
            <a:ext cx="3109775" cy="211343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DC362BDA-E4C9-6C2F-623F-E105A83EF40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55878" y="7921101"/>
            <a:ext cx="5832221" cy="216542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AACD3DD-DA9F-9AD2-5C17-9A00080E1E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8402" y="10231132"/>
            <a:ext cx="5188146" cy="2493480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271595EF-159D-B2D6-42A6-BDCB4704E71E}"/>
              </a:ext>
            </a:extLst>
          </p:cNvPr>
          <p:cNvSpPr/>
          <p:nvPr/>
        </p:nvSpPr>
        <p:spPr>
          <a:xfrm>
            <a:off x="12569" y="5006201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1BC15C2-0879-5726-CB89-EEAD6BA9C16D}"/>
              </a:ext>
            </a:extLst>
          </p:cNvPr>
          <p:cNvSpPr/>
          <p:nvPr/>
        </p:nvSpPr>
        <p:spPr>
          <a:xfrm>
            <a:off x="59878" y="2603555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29CE-5682-8FEF-73E8-5196311DC021}"/>
              </a:ext>
            </a:extLst>
          </p:cNvPr>
          <p:cNvSpPr txBox="1"/>
          <p:nvPr/>
        </p:nvSpPr>
        <p:spPr>
          <a:xfrm>
            <a:off x="4654213" y="7967694"/>
            <a:ext cx="992792" cy="297962"/>
          </a:xfrm>
          <a:prstGeom prst="rect">
            <a:avLst/>
          </a:prstGeom>
          <a:solidFill>
            <a:srgbClr val="A02A93"/>
          </a:solidFill>
        </p:spPr>
        <p:txBody>
          <a:bodyPr wrap="square" tIns="36000" rtlCol="0">
            <a:spAutoFit/>
          </a:bodyPr>
          <a:lstStyle/>
          <a:p>
            <a:r>
              <a:rPr lang="en-TH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TZ (</a:t>
            </a:r>
            <a:r>
              <a:rPr lang="en-US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TH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TH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389772-1FF9-AFB7-47B9-AC3B3FF87941}"/>
              </a:ext>
            </a:extLst>
          </p:cNvPr>
          <p:cNvSpPr txBox="1"/>
          <p:nvPr/>
        </p:nvSpPr>
        <p:spPr>
          <a:xfrm>
            <a:off x="5775592" y="7967694"/>
            <a:ext cx="992792" cy="297962"/>
          </a:xfrm>
          <a:prstGeom prst="rect">
            <a:avLst/>
          </a:prstGeom>
          <a:solidFill>
            <a:srgbClr val="A02A93"/>
          </a:solidFill>
        </p:spPr>
        <p:txBody>
          <a:bodyPr wrap="square" tIns="36000" rtlCol="0">
            <a:spAutoFit/>
          </a:bodyPr>
          <a:lstStyle/>
          <a:p>
            <a:r>
              <a:rPr lang="en-TH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p (</a:t>
            </a:r>
            <a:r>
              <a:rPr lang="en-US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TH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TH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CEF5B06-9A9B-F7BE-EBA9-5F7F40C7A6E5}"/>
              </a:ext>
            </a:extLst>
          </p:cNvPr>
          <p:cNvSpPr txBox="1"/>
          <p:nvPr/>
        </p:nvSpPr>
        <p:spPr>
          <a:xfrm>
            <a:off x="509278" y="10303565"/>
            <a:ext cx="992792" cy="259200"/>
          </a:xfrm>
          <a:prstGeom prst="rect">
            <a:avLst/>
          </a:prstGeom>
          <a:solidFill>
            <a:srgbClr val="339ED5"/>
          </a:solidFill>
        </p:spPr>
        <p:txBody>
          <a:bodyPr wrap="square" tIns="36000" rtlCol="0">
            <a:spAutoFit/>
          </a:bodyPr>
          <a:lstStyle/>
          <a:p>
            <a:r>
              <a:rPr lang="en-TH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TZ (</a:t>
            </a:r>
            <a:r>
              <a:rPr lang="en-US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TH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TH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A1F120F-9499-F032-5F3B-1BF99DC246EE}"/>
              </a:ext>
            </a:extLst>
          </p:cNvPr>
          <p:cNvSpPr txBox="1"/>
          <p:nvPr/>
        </p:nvSpPr>
        <p:spPr>
          <a:xfrm>
            <a:off x="1800990" y="10303565"/>
            <a:ext cx="992792" cy="297962"/>
          </a:xfrm>
          <a:prstGeom prst="rect">
            <a:avLst/>
          </a:prstGeom>
          <a:solidFill>
            <a:srgbClr val="339ED5"/>
          </a:solidFill>
        </p:spPr>
        <p:txBody>
          <a:bodyPr wrap="square" tIns="36000" rtlCol="0">
            <a:spAutoFit/>
          </a:bodyPr>
          <a:lstStyle/>
          <a:p>
            <a:r>
              <a:rPr lang="en-US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p</a:t>
            </a:r>
            <a:r>
              <a:rPr lang="en-TH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TH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TH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1B81732-E937-D9AF-2C1E-B0F066B09FB8}"/>
              </a:ext>
            </a:extLst>
          </p:cNvPr>
          <p:cNvSpPr txBox="1"/>
          <p:nvPr/>
        </p:nvSpPr>
        <p:spPr>
          <a:xfrm>
            <a:off x="1800990" y="10601527"/>
            <a:ext cx="992792" cy="198000"/>
          </a:xfrm>
          <a:prstGeom prst="rect">
            <a:avLst/>
          </a:prstGeom>
          <a:solidFill>
            <a:srgbClr val="339ED5"/>
          </a:solidFill>
        </p:spPr>
        <p:txBody>
          <a:bodyPr wrap="square" tIns="36000" rtlCol="0">
            <a:spAutoFit/>
          </a:bodyPr>
          <a:lstStyle/>
          <a:p>
            <a:endParaRPr lang="en-TH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46139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034723C-2CC0-F1A8-2D03-1F51D06A6474}"/>
              </a:ext>
            </a:extLst>
          </p:cNvPr>
          <p:cNvSpPr txBox="1"/>
          <p:nvPr/>
        </p:nvSpPr>
        <p:spPr>
          <a:xfrm>
            <a:off x="368136" y="989656"/>
            <a:ext cx="8075220" cy="35468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Figure S4. Synergy analysis of </a:t>
            </a:r>
            <a:r>
              <a:rPr lang="en-US" sz="14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and bortezomib (BTZ) in MOLT4 cells.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(A) MOLT4 cells were treated with pretreatment 1h for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(4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) follow by BTZ with various concentration of (0-10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n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) for 24 h and measure by WST-1 assay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se-response curves were fitted using a four-parameter logistic (4PL) nonlinear regression model. IC₅₀ is defined as the concentration corresponding to the midpoint between the upper (Top) and lower (Bottom) plateaus of the fitted curve.</a:t>
            </a:r>
            <a:r>
              <a:rPr lang="en-TH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(B)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ompuSy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analysis was performed on cytotoxicity data to assess the synergistic interaction between BTZ and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in MOLT4 cells. Dose-response curves for BTZ,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, and their combination were generated. 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(C)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ombination Index (CI) plots showed CI values less than 1, indicating a synergistic effect between BTZ and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. 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(D)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Isobolograms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illustrated the effective doses required to achieve 50% (Fa 0.5) inhibition for each drug alone, with synergism indicated when dose combinations fell below the corresponding Fa lines. (E) Dose Reduction Index (DRI) values for the BTZ and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combination are shown, where DRI values greater than 1 suggest a beneficial interaction. (F, G) The presented data were generated using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ompuSy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and are based on three independent experiments. Fa, fraction affected. </a:t>
            </a:r>
            <a:endParaRPr lang="en-TH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4554131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6F7E22-D497-48E8-85F3-164D56E490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DABD2372-CC66-CCE6-F1B1-21E1397F37AE}"/>
              </a:ext>
            </a:extLst>
          </p:cNvPr>
          <p:cNvGrpSpPr/>
          <p:nvPr/>
        </p:nvGrpSpPr>
        <p:grpSpPr>
          <a:xfrm>
            <a:off x="456922" y="965240"/>
            <a:ext cx="3727908" cy="1789206"/>
            <a:chOff x="5809639" y="116680"/>
            <a:chExt cx="3727908" cy="178920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464833D-2221-F367-69E2-B4088EAA1F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96073" y="850479"/>
              <a:ext cx="2771780" cy="4844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A809AD5-8557-74C8-0943-A188AB29503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96073" y="1383337"/>
              <a:ext cx="2771780" cy="5225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4B59824-5DB9-8B08-03C6-9DECA1E0AC4E}"/>
                </a:ext>
              </a:extLst>
            </p:cNvPr>
            <p:cNvSpPr txBox="1"/>
            <p:nvPr/>
          </p:nvSpPr>
          <p:spPr>
            <a:xfrm>
              <a:off x="6455453" y="583830"/>
              <a:ext cx="3082094" cy="276999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TH" sz="1200" dirty="0">
                  <a:latin typeface="Arial" panose="020B0604020202020204" pitchFamily="34" charset="0"/>
                  <a:cs typeface="Arial" panose="020B0604020202020204" pitchFamily="34" charset="0"/>
                </a:rPr>
                <a:t>  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TH" sz="1200" dirty="0">
                  <a:latin typeface="Arial" panose="020B0604020202020204" pitchFamily="34" charset="0"/>
                  <a:cs typeface="Arial" panose="020B0604020202020204" pitchFamily="34" charset="0"/>
                </a:rPr>
                <a:t>  0     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TH" sz="1200" dirty="0">
                  <a:latin typeface="Arial" panose="020B0604020202020204" pitchFamily="34" charset="0"/>
                  <a:cs typeface="Arial" panose="020B0604020202020204" pitchFamily="34" charset="0"/>
                </a:rPr>
                <a:t>1      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TH" sz="1200" dirty="0">
                  <a:latin typeface="Arial" panose="020B0604020202020204" pitchFamily="34" charset="0"/>
                  <a:cs typeface="Arial" panose="020B0604020202020204" pitchFamily="34" charset="0"/>
                </a:rPr>
                <a:t>2        4      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TH" sz="1200" dirty="0">
                  <a:latin typeface="Arial" panose="020B0604020202020204" pitchFamily="34" charset="0"/>
                  <a:cs typeface="Arial" panose="020B0604020202020204" pitchFamily="34" charset="0"/>
                </a:rPr>
                <a:t>8   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TH" sz="1200" dirty="0">
                  <a:latin typeface="Arial" panose="020B0604020202020204" pitchFamily="34" charset="0"/>
                  <a:cs typeface="Arial" panose="020B0604020202020204" pitchFamily="34" charset="0"/>
                </a:rPr>
                <a:t> Tu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7EA021CA-CB0E-2BDB-97DA-8C3F18367DFE}"/>
                </a:ext>
              </a:extLst>
            </p:cNvPr>
            <p:cNvCxnSpPr/>
            <p:nvPr/>
          </p:nvCxnSpPr>
          <p:spPr>
            <a:xfrm>
              <a:off x="7230574" y="506491"/>
              <a:ext cx="148485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5BF172B-32A5-BD2B-5AB3-DEFCC04FED0D}"/>
                </a:ext>
              </a:extLst>
            </p:cNvPr>
            <p:cNvSpPr/>
            <p:nvPr/>
          </p:nvSpPr>
          <p:spPr>
            <a:xfrm>
              <a:off x="7230574" y="116680"/>
              <a:ext cx="1761688" cy="33014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ypripedin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FA36339-C1A4-3360-59D9-7629B5522E80}"/>
                </a:ext>
              </a:extLst>
            </p:cNvPr>
            <p:cNvSpPr/>
            <p:nvPr/>
          </p:nvSpPr>
          <p:spPr>
            <a:xfrm>
              <a:off x="5825573" y="886151"/>
              <a:ext cx="838200" cy="33864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RP78 (78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B9F91208-DCF6-EE2A-2812-397E3088C8B2}"/>
                </a:ext>
              </a:extLst>
            </p:cNvPr>
            <p:cNvSpPr/>
            <p:nvPr/>
          </p:nvSpPr>
          <p:spPr>
            <a:xfrm>
              <a:off x="5809639" y="1426501"/>
              <a:ext cx="868422" cy="34683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43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B0742E4-993A-36B8-9D94-1B0BDB3FD619}"/>
                </a:ext>
              </a:extLst>
            </p:cNvPr>
            <p:cNvSpPr/>
            <p:nvPr/>
          </p:nvSpPr>
          <p:spPr>
            <a:xfrm>
              <a:off x="5809639" y="313655"/>
              <a:ext cx="838200" cy="33864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LT4</a:t>
              </a:r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B9FAEACB-A0A2-26C6-4E05-AF4D5653B7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72000" y="841451"/>
            <a:ext cx="3467100" cy="2463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263E311-66E2-5F63-6304-364B5F56CD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95122" y="3081584"/>
            <a:ext cx="2139881" cy="2651990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A8775B28-B37E-380E-CF62-EF5EC1912475}"/>
              </a:ext>
            </a:extLst>
          </p:cNvPr>
          <p:cNvSpPr/>
          <p:nvPr/>
        </p:nvSpPr>
        <p:spPr>
          <a:xfrm>
            <a:off x="517165" y="721424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9CB2337-2404-663E-6C31-60F709A9C62C}"/>
              </a:ext>
            </a:extLst>
          </p:cNvPr>
          <p:cNvSpPr/>
          <p:nvPr/>
        </p:nvSpPr>
        <p:spPr>
          <a:xfrm>
            <a:off x="456922" y="2782268"/>
            <a:ext cx="486136" cy="38196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CA0BD0-21FB-E955-D9B5-EFFFD17F049E}"/>
              </a:ext>
            </a:extLst>
          </p:cNvPr>
          <p:cNvSpPr txBox="1"/>
          <p:nvPr/>
        </p:nvSpPr>
        <p:spPr>
          <a:xfrm>
            <a:off x="517165" y="6060712"/>
            <a:ext cx="7938065" cy="18124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Figure S5. </a:t>
            </a:r>
            <a:r>
              <a:rPr lang="en-US" sz="14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modulates GRP78 at transcriptional and translational level in MOLT4 cells.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(A)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MOLT4 cells were treated for 24 h with vehicle (0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), 1, 2, 4, or 8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, or 2.5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tunicamycin (Tu) as a positive control, and lysates were analyzed by Western blot. β-Actin serves as a loading control.  (B) Cells were treated for 24 h with vehicle (0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), 2, or 8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μM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Cypripedin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, and total RNA was analyzed by SYBR Green 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qRT</a:t>
            </a:r>
            <a:r>
              <a:rPr lang="en-US" sz="14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Cordia New" panose="020B0304020202020204" pitchFamily="34" charset="-34"/>
              </a:rPr>
              <a:t>-PCR. Bar graphs show relative mRNA expression of GRP78 normalized to GAPDH and plotted relative to control (mean ± SD, n = 3). (***p &lt; 0.001 vs. control; one-way ANOVA with Tukey’s post hoc test).</a:t>
            </a:r>
            <a:endParaRPr lang="en-TH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3863207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F3188DA-C8CC-BD9F-FA53-1750039A4D71}"/>
              </a:ext>
            </a:extLst>
          </p:cNvPr>
          <p:cNvSpPr txBox="1"/>
          <p:nvPr/>
        </p:nvSpPr>
        <p:spPr>
          <a:xfrm>
            <a:off x="1311211" y="5511264"/>
            <a:ext cx="6690273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. HSPA5 (GRP78) dependency across cancer cell lineages.</a:t>
            </a:r>
          </a:p>
          <a:p>
            <a:pPr algn="thaiDist">
              <a:buNone/>
            </a:pPr>
            <a:b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oxplot showing CRISPR-based gene dependency scores for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SPA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cross cancer cell lines from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epMa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ataset, grouped into lymphoid and non-lymphoid (“Other”) lineages. Each dot represents an individual cell line. The box indicates the interquartile range (IQR), with the median shown as a horizontal line, and whiskers extending to 1.5× IQR.</a:t>
            </a:r>
          </a:p>
          <a:p>
            <a:pPr algn="thaiDist">
              <a:buNone/>
            </a:pP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SPA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exhibits consistently high dependency scores across cancer cell lines, consistent with its role as a central regulator of endoplasmic reticulum (ER)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roteostasi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A modest but statistically significant difference in dependency was observed between lymphoid and non-lymphoid lineages (Mann–Whitney U test,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= 7.68 × 10⁻⁴)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D9C5FB89-CDFD-84DC-131C-E5EB1CE94FF1}"/>
              </a:ext>
            </a:extLst>
          </p:cNvPr>
          <p:cNvGrpSpPr/>
          <p:nvPr/>
        </p:nvGrpSpPr>
        <p:grpSpPr>
          <a:xfrm>
            <a:off x="2729983" y="2120256"/>
            <a:ext cx="1608778" cy="281097"/>
            <a:chOff x="2729983" y="1205855"/>
            <a:chExt cx="1608778" cy="281097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8193F3F2-7DCF-2279-A5C8-7BF21E4EBB98}"/>
                </a:ext>
              </a:extLst>
            </p:cNvPr>
            <p:cNvCxnSpPr>
              <a:cxnSpLocks/>
            </p:cNvCxnSpPr>
            <p:nvPr/>
          </p:nvCxnSpPr>
          <p:spPr>
            <a:xfrm>
              <a:off x="2729983" y="1408451"/>
              <a:ext cx="1608778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0D436037-4C7D-736A-51CE-8A80068CEA3F}"/>
                </a:ext>
              </a:extLst>
            </p:cNvPr>
            <p:cNvCxnSpPr>
              <a:cxnSpLocks/>
            </p:cNvCxnSpPr>
            <p:nvPr/>
          </p:nvCxnSpPr>
          <p:spPr>
            <a:xfrm>
              <a:off x="2736539" y="1404531"/>
              <a:ext cx="0" cy="82421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9EF0136-B41B-2469-D039-1BCE30186709}"/>
                </a:ext>
              </a:extLst>
            </p:cNvPr>
            <p:cNvCxnSpPr>
              <a:cxnSpLocks/>
            </p:cNvCxnSpPr>
            <p:nvPr/>
          </p:nvCxnSpPr>
          <p:spPr>
            <a:xfrm>
              <a:off x="4334152" y="1404531"/>
              <a:ext cx="0" cy="82421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793199C-58AA-7A07-46E4-A838ADD36744}"/>
                </a:ext>
              </a:extLst>
            </p:cNvPr>
            <p:cNvSpPr txBox="1"/>
            <p:nvPr/>
          </p:nvSpPr>
          <p:spPr>
            <a:xfrm>
              <a:off x="2788847" y="1205855"/>
              <a:ext cx="14910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/>
                <a:t>p </a:t>
              </a:r>
              <a:r>
                <a:rPr lang="en-US" sz="800" dirty="0"/>
                <a:t> = 7.68 × 10⁻⁴ </a:t>
              </a:r>
              <a:endParaRPr lang="en-TH" sz="800" dirty="0"/>
            </a:p>
          </p:txBody>
        </p:sp>
      </p:grpSp>
      <p:pic>
        <p:nvPicPr>
          <p:cNvPr id="1028" name="Picture 4">
            <a:extLst>
              <a:ext uri="{FF2B5EF4-FFF2-40B4-BE49-F238E27FC236}">
                <a16:creationId xmlns:a16="http://schemas.microsoft.com/office/drawing/2014/main" id="{F601264B-2AF3-6B3F-0BF7-A52AF1D429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2961" y="2368527"/>
            <a:ext cx="3665536" cy="30442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56649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ACA4E3F41A9DE40999089A53007D482" ma:contentTypeVersion="17" ma:contentTypeDescription="Create a new document." ma:contentTypeScope="" ma:versionID="bc551df6d0aa9d1f5759f81ea4c652b7">
  <xsd:schema xmlns:xsd="http://www.w3.org/2001/XMLSchema" xmlns:xs="http://www.w3.org/2001/XMLSchema" xmlns:p="http://schemas.microsoft.com/office/2006/metadata/properties" xmlns:ns2="4d63bb79-bda7-449b-9c94-f551d248cb30" xmlns:ns3="ed3d47b3-57d1-47d5-94ce-93c17c11a905" targetNamespace="http://schemas.microsoft.com/office/2006/metadata/properties" ma:root="true" ma:fieldsID="544b74c885d5c553fd0357937a36be31" ns2:_="" ns3:_="">
    <xsd:import namespace="4d63bb79-bda7-449b-9c94-f551d248cb30"/>
    <xsd:import namespace="ed3d47b3-57d1-47d5-94ce-93c17c11a90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d63bb79-bda7-449b-9c94-f551d248cb3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c46ab3c0-9aa0-433c-9274-b865a251c8d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4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3d47b3-57d1-47d5-94ce-93c17c11a905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25b3a41c-ff74-483b-980b-5a20978521b8}" ma:internalName="TaxCatchAll" ma:showField="CatchAllData" ma:web="ed3d47b3-57d1-47d5-94ce-93c17c11a90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ed3d47b3-57d1-47d5-94ce-93c17c11a905" xsi:nil="true"/>
    <lcf76f155ced4ddcb4097134ff3c332f xmlns="4d63bb79-bda7-449b-9c94-f551d248cb30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A209861-73AC-4EA2-A692-891C8592B18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d63bb79-bda7-449b-9c94-f551d248cb30"/>
    <ds:schemaRef ds:uri="ed3d47b3-57d1-47d5-94ce-93c17c11a90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1A2DA0D-BBBA-4103-B936-565D3422103D}">
  <ds:schemaRefs>
    <ds:schemaRef ds:uri="http://www.w3.org/XML/1998/namespace"/>
    <ds:schemaRef ds:uri="http://schemas.microsoft.com/office/2006/metadata/properties"/>
    <ds:schemaRef ds:uri="http://purl.org/dc/dcmitype/"/>
    <ds:schemaRef ds:uri="http://purl.org/dc/elements/1.1/"/>
    <ds:schemaRef ds:uri="http://schemas.microsoft.com/office/2006/documentManagement/types"/>
    <ds:schemaRef ds:uri="ed3d47b3-57d1-47d5-94ce-93c17c11a905"/>
    <ds:schemaRef ds:uri="http://schemas.microsoft.com/office/infopath/2007/PartnerControls"/>
    <ds:schemaRef ds:uri="http://schemas.openxmlformats.org/package/2006/metadata/core-properties"/>
    <ds:schemaRef ds:uri="4d63bb79-bda7-449b-9c94-f551d248cb30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42A160B6-67E7-4078-A225-259CFFDFC40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0</TotalTime>
  <Words>1135</Words>
  <Application>Microsoft Office PowerPoint</Application>
  <PresentationFormat>Custom</PresentationFormat>
  <Paragraphs>54</Paragraphs>
  <Slides>8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in Ei</dc:creator>
  <cp:lastModifiedBy>Preedakorn Chunhacha</cp:lastModifiedBy>
  <cp:revision>24</cp:revision>
  <dcterms:created xsi:type="dcterms:W3CDTF">2025-05-28T05:07:10Z</dcterms:created>
  <dcterms:modified xsi:type="dcterms:W3CDTF">2026-05-22T06:0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ACA4E3F41A9DE40999089A53007D482</vt:lpwstr>
  </property>
  <property fmtid="{D5CDD505-2E9C-101B-9397-08002B2CF9AE}" pid="3" name="MediaServiceImageTags">
    <vt:lpwstr/>
  </property>
</Properties>
</file>